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65" d="100"/>
          <a:sy n="65" d="100"/>
        </p:scale>
        <p:origin x="1536" y="6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EBC9-B4B8-4412-90BC-6A8356FF41B9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219AE-8E99-4E54-BC9B-EB7CEEF63CA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827638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EBC9-B4B8-4412-90BC-6A8356FF41B9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219AE-8E99-4E54-BC9B-EB7CEEF63CA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635111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EBC9-B4B8-4412-90BC-6A8356FF41B9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219AE-8E99-4E54-BC9B-EB7CEEF63CA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16285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EBC9-B4B8-4412-90BC-6A8356FF41B9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219AE-8E99-4E54-BC9B-EB7CEEF63CA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08175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EBC9-B4B8-4412-90BC-6A8356FF41B9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219AE-8E99-4E54-BC9B-EB7CEEF63CA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48113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EBC9-B4B8-4412-90BC-6A8356FF41B9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219AE-8E99-4E54-BC9B-EB7CEEF63CA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682751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EBC9-B4B8-4412-90BC-6A8356FF41B9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219AE-8E99-4E54-BC9B-EB7CEEF63CA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911345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EBC9-B4B8-4412-90BC-6A8356FF41B9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219AE-8E99-4E54-BC9B-EB7CEEF63CA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47334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EBC9-B4B8-4412-90BC-6A8356FF41B9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219AE-8E99-4E54-BC9B-EB7CEEF63CA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704143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EBC9-B4B8-4412-90BC-6A8356FF41B9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219AE-8E99-4E54-BC9B-EB7CEEF63CA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324851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EBC9-B4B8-4412-90BC-6A8356FF41B9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219AE-8E99-4E54-BC9B-EB7CEEF63CA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701990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14EBC9-B4B8-4412-90BC-6A8356FF41B9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B219AE-8E99-4E54-BC9B-EB7CEEF63CA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32169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46" name="Group 12"/>
          <p:cNvGrpSpPr>
            <a:grpSpLocks/>
          </p:cNvGrpSpPr>
          <p:nvPr/>
        </p:nvGrpSpPr>
        <p:grpSpPr bwMode="auto">
          <a:xfrm>
            <a:off x="436685" y="174625"/>
            <a:ext cx="2025162" cy="3219450"/>
            <a:chOff x="0" y="1021185"/>
            <a:chExt cx="2193750" cy="3220132"/>
          </a:xfrm>
        </p:grpSpPr>
        <p:sp>
          <p:nvSpPr>
            <p:cNvPr id="2" name="TextBox 1"/>
            <p:cNvSpPr txBox="1"/>
            <p:nvPr/>
          </p:nvSpPr>
          <p:spPr>
            <a:xfrm>
              <a:off x="807974" y="1021185"/>
              <a:ext cx="695270" cy="317567"/>
            </a:xfrm>
            <a:prstGeom prst="rect">
              <a:avLst/>
            </a:prstGeom>
            <a:solidFill>
              <a:schemeClr val="tx1"/>
            </a:solidFill>
          </p:spPr>
          <p:txBody>
            <a:bodyPr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IN" sz="1463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C-4</a:t>
              </a:r>
            </a:p>
          </p:txBody>
        </p:sp>
        <p:pic>
          <p:nvPicPr>
            <p:cNvPr id="6165" name="Picture 6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2778817"/>
              <a:ext cx="2193750" cy="1462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66" name="Picture 7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1316317"/>
              <a:ext cx="2193750" cy="1462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6147" name="Group 13"/>
          <p:cNvGrpSpPr>
            <a:grpSpLocks/>
          </p:cNvGrpSpPr>
          <p:nvPr/>
        </p:nvGrpSpPr>
        <p:grpSpPr bwMode="auto">
          <a:xfrm>
            <a:off x="2637693" y="206375"/>
            <a:ext cx="2025162" cy="3219450"/>
            <a:chOff x="2193750" y="1021185"/>
            <a:chExt cx="2193750" cy="3220132"/>
          </a:xfrm>
        </p:grpSpPr>
        <p:sp>
          <p:nvSpPr>
            <p:cNvPr id="3" name="TextBox 2"/>
            <p:cNvSpPr txBox="1"/>
            <p:nvPr/>
          </p:nvSpPr>
          <p:spPr>
            <a:xfrm>
              <a:off x="2939815" y="1021185"/>
              <a:ext cx="696857" cy="317567"/>
            </a:xfrm>
            <a:prstGeom prst="rect">
              <a:avLst/>
            </a:prstGeom>
            <a:solidFill>
              <a:schemeClr val="tx1"/>
            </a:solidFill>
          </p:spPr>
          <p:txBody>
            <a:bodyPr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IN" sz="1463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C-6</a:t>
              </a:r>
            </a:p>
          </p:txBody>
        </p:sp>
        <p:pic>
          <p:nvPicPr>
            <p:cNvPr id="6162" name="Picture 8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93750" y="2778817"/>
              <a:ext cx="2193750" cy="1462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63" name="Picture 9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93750" y="1316317"/>
              <a:ext cx="2193750" cy="1462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6148" name="Group 14"/>
          <p:cNvGrpSpPr>
            <a:grpSpLocks/>
          </p:cNvGrpSpPr>
          <p:nvPr/>
        </p:nvGrpSpPr>
        <p:grpSpPr bwMode="auto">
          <a:xfrm>
            <a:off x="4834305" y="127001"/>
            <a:ext cx="2025162" cy="3267075"/>
            <a:chOff x="4387500" y="973373"/>
            <a:chExt cx="2193750" cy="3267944"/>
          </a:xfrm>
        </p:grpSpPr>
        <p:sp>
          <p:nvSpPr>
            <p:cNvPr id="4" name="TextBox 3"/>
            <p:cNvSpPr txBox="1"/>
            <p:nvPr/>
          </p:nvSpPr>
          <p:spPr>
            <a:xfrm>
              <a:off x="4800217" y="973373"/>
              <a:ext cx="804798" cy="542728"/>
            </a:xfrm>
            <a:prstGeom prst="rect">
              <a:avLst/>
            </a:prstGeom>
            <a:solidFill>
              <a:schemeClr val="tx1"/>
            </a:solidFill>
          </p:spPr>
          <p:txBody>
            <a:bodyPr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IN" sz="1463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C-310</a:t>
              </a:r>
            </a:p>
          </p:txBody>
        </p:sp>
        <p:pic>
          <p:nvPicPr>
            <p:cNvPr id="6159" name="Picture 10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87500" y="2778817"/>
              <a:ext cx="2193750" cy="1462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60" name="Picture 11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87500" y="1316317"/>
              <a:ext cx="2193750" cy="1462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6149" name="Group 19"/>
          <p:cNvGrpSpPr>
            <a:grpSpLocks/>
          </p:cNvGrpSpPr>
          <p:nvPr/>
        </p:nvGrpSpPr>
        <p:grpSpPr bwMode="auto">
          <a:xfrm>
            <a:off x="432289" y="3587751"/>
            <a:ext cx="1997319" cy="3197225"/>
            <a:chOff x="-145041" y="4757682"/>
            <a:chExt cx="2163780" cy="3197459"/>
          </a:xfrm>
        </p:grpSpPr>
        <p:sp>
          <p:nvSpPr>
            <p:cNvPr id="5" name="TextBox 4"/>
            <p:cNvSpPr txBox="1"/>
            <p:nvPr/>
          </p:nvSpPr>
          <p:spPr>
            <a:xfrm>
              <a:off x="547115" y="4757682"/>
              <a:ext cx="1025534" cy="542624"/>
            </a:xfrm>
            <a:prstGeom prst="rect">
              <a:avLst/>
            </a:prstGeom>
            <a:solidFill>
              <a:schemeClr val="tx1"/>
            </a:solidFill>
          </p:spPr>
          <p:txBody>
            <a:bodyPr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IN" sz="1463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ctronol</a:t>
              </a:r>
              <a:endParaRPr lang="en-IN" sz="1463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156" name="Picture 16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145041" y="6515141"/>
              <a:ext cx="2160000" cy="144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57" name="Picture 18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141261" y="5075141"/>
              <a:ext cx="2160000" cy="144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6150" name="Group 22"/>
          <p:cNvGrpSpPr>
            <a:grpSpLocks/>
          </p:cNvGrpSpPr>
          <p:nvPr/>
        </p:nvGrpSpPr>
        <p:grpSpPr bwMode="auto">
          <a:xfrm>
            <a:off x="2520462" y="3587750"/>
            <a:ext cx="2051538" cy="3221038"/>
            <a:chOff x="5522129" y="3219260"/>
            <a:chExt cx="2222586" cy="3222095"/>
          </a:xfrm>
        </p:grpSpPr>
        <p:sp>
          <p:nvSpPr>
            <p:cNvPr id="6" name="TextBox 5"/>
            <p:cNvSpPr txBox="1"/>
            <p:nvPr/>
          </p:nvSpPr>
          <p:spPr>
            <a:xfrm>
              <a:off x="6246057" y="3219260"/>
              <a:ext cx="803306" cy="542762"/>
            </a:xfrm>
            <a:prstGeom prst="rect">
              <a:avLst/>
            </a:prstGeom>
            <a:solidFill>
              <a:schemeClr val="tx1"/>
            </a:solidFill>
          </p:spPr>
          <p:txBody>
            <a:bodyPr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IN" sz="1463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</a:p>
          </p:txBody>
        </p:sp>
        <p:pic>
          <p:nvPicPr>
            <p:cNvPr id="6153" name="Picture 20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22129" y="4978855"/>
              <a:ext cx="2193750" cy="1462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54" name="Picture 21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50965" y="3527686"/>
              <a:ext cx="2193750" cy="1462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6151" name="TextBox 17"/>
          <p:cNvSpPr txBox="1">
            <a:spLocks noChangeArrowheads="1"/>
          </p:cNvSpPr>
          <p:nvPr/>
        </p:nvSpPr>
        <p:spPr bwMode="auto">
          <a:xfrm>
            <a:off x="4662854" y="3816350"/>
            <a:ext cx="4356589" cy="3041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just" eaLnBrk="1" hangingPunct="1">
              <a:lnSpc>
                <a:spcPct val="107000"/>
              </a:lnSpc>
              <a:spcAft>
                <a:spcPts val="800"/>
              </a:spcAft>
            </a:pPr>
            <a:r>
              <a:rPr lang="en-US">
                <a:latin typeface="Times New Roman" pitchFamily="18" charset="0"/>
                <a:ea typeface="DengXian" pitchFamily="2" charset="-122"/>
                <a:cs typeface="Arial" charset="0"/>
              </a:rPr>
              <a:t>Supplementary Figure 4 On-field trials of endophytes (TC-4, TC-6 and TC-310) against bacterial blight of pomegranate. </a:t>
            </a:r>
            <a:r>
              <a:rPr lang="en-US" dirty="0">
                <a:latin typeface="Times New Roman" pitchFamily="18" charset="0"/>
                <a:ea typeface="DengXian" pitchFamily="2" charset="-122"/>
                <a:cs typeface="Arial" charset="0"/>
              </a:rPr>
              <a:t>Bacterial endophytes (TC-4, TC-6 and TC-310) belonging to the genus </a:t>
            </a:r>
            <a:r>
              <a:rPr lang="en-US" i="1" dirty="0">
                <a:latin typeface="Times New Roman" pitchFamily="18" charset="0"/>
                <a:ea typeface="DengXian" pitchFamily="2" charset="-122"/>
                <a:cs typeface="Arial" charset="0"/>
              </a:rPr>
              <a:t>Bacillus</a:t>
            </a:r>
            <a:r>
              <a:rPr lang="en-US" dirty="0">
                <a:latin typeface="Times New Roman" pitchFamily="18" charset="0"/>
                <a:ea typeface="DengXian" pitchFamily="2" charset="-122"/>
                <a:cs typeface="Arial" charset="0"/>
              </a:rPr>
              <a:t> were tested on-field for successful management of bacterial blight disease of pomegranate. The trial also included a chemical immune-modulator, </a:t>
            </a:r>
            <a:r>
              <a:rPr lang="en-US" dirty="0" err="1">
                <a:latin typeface="Times New Roman" pitchFamily="18" charset="0"/>
                <a:ea typeface="DengXian" pitchFamily="2" charset="-122"/>
                <a:cs typeface="Arial" charset="0"/>
              </a:rPr>
              <a:t>bactronol</a:t>
            </a:r>
            <a:r>
              <a:rPr lang="en-US" dirty="0">
                <a:latin typeface="Times New Roman" pitchFamily="18" charset="0"/>
                <a:ea typeface="DengXian" pitchFamily="2" charset="-122"/>
                <a:cs typeface="Arial" charset="0"/>
              </a:rPr>
              <a:t> (2-Bromo-2-Nitro-1, 3-Propanediol) and water-control.</a:t>
            </a:r>
            <a:endParaRPr lang="en-IN" sz="1600" dirty="0">
              <a:ea typeface="DengXian" pitchFamily="2" charset="-122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36901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9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DengXian</vt:lpstr>
      <vt:lpstr>Arial</vt:lpstr>
      <vt:lpstr>Calibri</vt:lpstr>
      <vt:lpstr>Times New Roman</vt:lpstr>
      <vt:lpstr>Office Theme</vt:lpstr>
      <vt:lpstr>PowerPoint Pre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mnath</dc:creator>
  <cp:lastModifiedBy>Ruchi Agarrwal</cp:lastModifiedBy>
  <cp:revision>2</cp:revision>
  <dcterms:created xsi:type="dcterms:W3CDTF">2024-09-04T07:36:31Z</dcterms:created>
  <dcterms:modified xsi:type="dcterms:W3CDTF">2024-11-03T09:59:30Z</dcterms:modified>
</cp:coreProperties>
</file>